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8"/>
  </p:notesMasterIdLst>
  <p:handoutMasterIdLst>
    <p:handoutMasterId r:id="rId19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72" r:id="rId12"/>
    <p:sldId id="273" r:id="rId13"/>
    <p:sldId id="266" r:id="rId14"/>
    <p:sldId id="267" r:id="rId15"/>
    <p:sldId id="269" r:id="rId16"/>
    <p:sldId id="270" r:id="rId17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2"/>
    <p:restoredTop sz="94664"/>
  </p:normalViewPr>
  <p:slideViewPr>
    <p:cSldViewPr snapToGrid="0" showGuides="1">
      <p:cViewPr varScale="1">
        <p:scale>
          <a:sx n="90" d="100"/>
          <a:sy n="90" d="100"/>
        </p:scale>
        <p:origin x="816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pPr/>
              <a:t>08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pPr/>
              <a:t>08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cap="small" dirty="0"/>
              <a:t>Post-operative myocardial infarction following aortic root surgery with coronary reimplantation: a case series treated with PCI</a:t>
            </a:r>
            <a:br>
              <a:rPr lang="en-GB" cap="small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/>
              <a:t>EHJ-CR-D-19-00139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June 2019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is complication is typically managed with re-operation involving resiting the coronary button or coronary bypass grafting (2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n these cases, emergency multidisciplinary team decision was based on input from cardiothoracic surgeons, cardiologists and cardiac anaesthetist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Management with PCI led to excellent angiographic results and prompt resolution of ST segment change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However, long-term performance of stents in the neo-ostium is unknown and more information is needed about long term outcome</a:t>
            </a: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sz="3200" b="0" dirty="0">
                <a:solidFill>
                  <a:srgbClr val="080808"/>
                </a:solidFill>
              </a:rPr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49" y="1275606"/>
            <a:ext cx="7200800" cy="2828561"/>
          </a:xfrm>
          <a:solidFill>
            <a:schemeClr val="bg1"/>
          </a:solidFill>
        </p:spPr>
        <p:txBody>
          <a:bodyPr>
            <a:normAutofit lnSpcReduction="10000"/>
          </a:bodyPr>
          <a:lstStyle/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GB" b="0" dirty="0"/>
              <a:t>Acute myocardial infarction is an uncommon but potentially life threatening complication following aortic root replacement with coronary reimplantation and can be due to obstruction of the re-implanted artery</a:t>
            </a:r>
          </a:p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GB" b="0" dirty="0"/>
              <a:t>PCI may be considered as a salvage treatment for these patients</a:t>
            </a:r>
          </a:p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GB" b="0" dirty="0"/>
              <a:t>Cardiothoracic centres should perform complex aortic root surgery within the setting of an experienced multidisciplinary team involving cardiac surgeons, cardiologists with allied health professional input</a:t>
            </a:r>
          </a:p>
          <a:p>
            <a:pPr marL="342900" lvl="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063624"/>
            <a:ext cx="7128792" cy="3465845"/>
          </a:xfrm>
        </p:spPr>
        <p:txBody>
          <a:bodyPr>
            <a:normAutofit fontScale="62500" lnSpcReduction="20000"/>
          </a:bodyPr>
          <a:lstStyle/>
          <a:p>
            <a:pPr marL="457200" indent="-457200">
              <a:buFont typeface="+mj-lt"/>
              <a:buAutoNum type="arabicPeriod"/>
            </a:pPr>
            <a:r>
              <a:rPr lang="en-GB" b="0" dirty="0"/>
              <a:t>Tsuji M, Kodera S, </a:t>
            </a:r>
            <a:r>
              <a:rPr lang="en-GB" b="0" dirty="0" err="1"/>
              <a:t>Oshima</a:t>
            </a:r>
            <a:r>
              <a:rPr lang="en-GB" b="0" dirty="0"/>
              <a:t> T, Uehara M, </a:t>
            </a:r>
            <a:r>
              <a:rPr lang="en-GB" b="0" dirty="0" err="1"/>
              <a:t>Kiyosue</a:t>
            </a:r>
            <a:r>
              <a:rPr lang="en-GB" b="0" dirty="0"/>
              <a:t> A, Ando J, et al. Coronary Artery Perforation During Percutaneous Coronary Intervention in a Patient with a Prior Modified Bentall Procedure. Int Heart J. 2018 Jul 31;59(4):848–53. 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 err="1"/>
              <a:t>Balbi</a:t>
            </a:r>
            <a:r>
              <a:rPr lang="en-GB" b="0" dirty="0"/>
              <a:t> M, </a:t>
            </a:r>
            <a:r>
              <a:rPr lang="en-GB" b="0" dirty="0" err="1"/>
              <a:t>Olivotti</a:t>
            </a:r>
            <a:r>
              <a:rPr lang="en-GB" b="0" dirty="0"/>
              <a:t> L, Scarano F, </a:t>
            </a:r>
            <a:r>
              <a:rPr lang="en-GB" b="0" dirty="0" err="1"/>
              <a:t>Bertero</a:t>
            </a:r>
            <a:r>
              <a:rPr lang="en-GB" b="0" dirty="0"/>
              <a:t> G, </a:t>
            </a:r>
            <a:r>
              <a:rPr lang="en-GB" b="0" dirty="0" err="1"/>
              <a:t>Passerone</a:t>
            </a:r>
            <a:r>
              <a:rPr lang="en-GB" b="0" dirty="0"/>
              <a:t> G, </a:t>
            </a:r>
            <a:r>
              <a:rPr lang="en-GB" b="0" dirty="0" err="1"/>
              <a:t>Brunelli</a:t>
            </a:r>
            <a:r>
              <a:rPr lang="en-GB" b="0" dirty="0"/>
              <a:t> C, et al. Percutaneous treatment of left main coronary stenosis as a late complication of </a:t>
            </a:r>
            <a:r>
              <a:rPr lang="en-GB" b="0" dirty="0" err="1"/>
              <a:t>bentall</a:t>
            </a:r>
            <a:r>
              <a:rPr lang="en-GB" b="0" dirty="0"/>
              <a:t> operation for acute aortic dissection. Catheter Cardiovasc </a:t>
            </a:r>
            <a:r>
              <a:rPr lang="en-GB" b="0" dirty="0" err="1"/>
              <a:t>Interv</a:t>
            </a:r>
            <a:r>
              <a:rPr lang="en-GB" b="0" dirty="0"/>
              <a:t> Off J Soc Card </a:t>
            </a:r>
            <a:r>
              <a:rPr lang="en-GB" b="0" dirty="0" err="1"/>
              <a:t>Angiogr</a:t>
            </a:r>
            <a:r>
              <a:rPr lang="en-GB" b="0" dirty="0"/>
              <a:t> </a:t>
            </a:r>
            <a:r>
              <a:rPr lang="en-GB" b="0" dirty="0" err="1"/>
              <a:t>Interv</a:t>
            </a:r>
            <a:r>
              <a:rPr lang="en-GB" b="0" dirty="0"/>
              <a:t>. 2004 Jul;62(3):343–5. 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 err="1"/>
              <a:t>Westaby</a:t>
            </a:r>
            <a:r>
              <a:rPr lang="en-GB" b="0" dirty="0"/>
              <a:t> S, Katsumata T, </a:t>
            </a:r>
            <a:r>
              <a:rPr lang="en-GB" b="0" dirty="0" err="1"/>
              <a:t>Vaccari</a:t>
            </a:r>
            <a:r>
              <a:rPr lang="en-GB" b="0" dirty="0"/>
              <a:t> G. Aortic root replacement with coronary button re-implantation: low risk and predictable outcome. Eur J Cardio-</a:t>
            </a:r>
            <a:r>
              <a:rPr lang="en-GB" b="0" dirty="0" err="1"/>
              <a:t>Thorac</a:t>
            </a:r>
            <a:r>
              <a:rPr lang="en-GB" b="0" dirty="0"/>
              <a:t> </a:t>
            </a:r>
            <a:r>
              <a:rPr lang="en-GB" b="0" dirty="0" err="1"/>
              <a:t>Surg</a:t>
            </a:r>
            <a:r>
              <a:rPr lang="en-GB" b="0" dirty="0"/>
              <a:t> Off J Eur Assoc Cardio-</a:t>
            </a:r>
            <a:r>
              <a:rPr lang="en-GB" b="0" dirty="0" err="1"/>
              <a:t>Thorac</a:t>
            </a:r>
            <a:r>
              <a:rPr lang="en-GB" b="0" dirty="0"/>
              <a:t> Surg. 2000 Mar;17(3):259–65. 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/>
              <a:t>Byrne JG, </a:t>
            </a:r>
            <a:r>
              <a:rPr lang="en-GB" b="0" dirty="0" err="1"/>
              <a:t>Karavas</a:t>
            </a:r>
            <a:r>
              <a:rPr lang="en-GB" b="0" dirty="0"/>
              <a:t> AN, </a:t>
            </a:r>
            <a:r>
              <a:rPr lang="en-GB" b="0" dirty="0" err="1"/>
              <a:t>Leacche</a:t>
            </a:r>
            <a:r>
              <a:rPr lang="en-GB" b="0" dirty="0"/>
              <a:t> M, </a:t>
            </a:r>
            <a:r>
              <a:rPr lang="en-GB" b="0" dirty="0" err="1"/>
              <a:t>Unic</a:t>
            </a:r>
            <a:r>
              <a:rPr lang="en-GB" b="0" dirty="0"/>
              <a:t> D, </a:t>
            </a:r>
            <a:r>
              <a:rPr lang="en-GB" b="0" dirty="0" err="1"/>
              <a:t>Rawn</a:t>
            </a:r>
            <a:r>
              <a:rPr lang="en-GB" b="0" dirty="0"/>
              <a:t> JD, Couper GS, et al. Impact of Concomitant Coronary Artery Bypass Grafting on Hospital Survival After Aortic Root Replacement. Ann </a:t>
            </a:r>
            <a:r>
              <a:rPr lang="en-GB" b="0" dirty="0" err="1"/>
              <a:t>Thorac</a:t>
            </a:r>
            <a:r>
              <a:rPr lang="en-GB" b="0" dirty="0"/>
              <a:t> Surg. 2005 Feb 1;79(2):511–6. 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/>
              <a:t>Marino M, Cellini C, </a:t>
            </a:r>
            <a:r>
              <a:rPr lang="en-GB" b="0" dirty="0" err="1"/>
              <a:t>Tsiopoulos</a:t>
            </a:r>
            <a:r>
              <a:rPr lang="en-GB" b="0" dirty="0"/>
              <a:t> V, </a:t>
            </a:r>
            <a:r>
              <a:rPr lang="en-GB" b="0" dirty="0" err="1"/>
              <a:t>Pavone</a:t>
            </a:r>
            <a:r>
              <a:rPr lang="en-GB" b="0" dirty="0"/>
              <a:t> N, </a:t>
            </a:r>
            <a:r>
              <a:rPr lang="en-GB" b="0" dirty="0" err="1"/>
              <a:t>Pavoni</a:t>
            </a:r>
            <a:r>
              <a:rPr lang="en-GB" b="0" dirty="0"/>
              <a:t> N, Zamparelli R, et al. A case of myocardial infarction effectively treated by emergency coronary stenting soon after a Bentall-De Bono aortic surgery. Cardiovasc Revascularization Med Mol </a:t>
            </a:r>
            <a:r>
              <a:rPr lang="en-GB" b="0" dirty="0" err="1"/>
              <a:t>Interv</a:t>
            </a:r>
            <a:r>
              <a:rPr lang="en-GB" b="0" dirty="0"/>
              <a:t>. 2010 Dec;11(4):263.e5-9. 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/>
              <a:t>Urbanski PP. Aortic root replacement with coronary button reimplantation. Eur J </a:t>
            </a:r>
            <a:r>
              <a:rPr lang="en-GB" b="0" dirty="0" err="1"/>
              <a:t>Cardiothorac</a:t>
            </a:r>
            <a:r>
              <a:rPr lang="en-GB" b="0" dirty="0"/>
              <a:t> Surg. 2000 Dec 1;18(6):732–732. 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00400" cy="3168000"/>
          </a:xfrm>
        </p:spPr>
        <p:txBody>
          <a:bodyPr>
            <a:normAutofit fontScale="92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Aortic root surgery involving coronary reimplantation may be complicated by ostial coronary stenosis (1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Resulting ischaemia may occur acutely or subacutely and is traditionally managed with repeat sternotomy with coronary button repositioning or bypass (2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We report a case series where urgent percutaneous coronary intervention (PCI) was used as a salvage technique in acute myocardial infarction following aortic root replacement as a valve sparing procedur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is report raises awareness of this complication including utility of PCI as a treatment option for patients in emergency/salvage situations</a:t>
            </a:r>
            <a:endParaRPr lang="en-GB" b="0" dirty="0"/>
          </a:p>
        </p:txBody>
      </p:sp>
      <p:sp>
        <p:nvSpPr>
          <p:cNvPr id="7" name="Footer Placeholder 2">
            <a:extLst>
              <a:ext uri="{FF2B5EF4-FFF2-40B4-BE49-F238E27FC236}">
                <a16:creationId xmlns:a16="http://schemas.microsoft.com/office/drawing/2014/main" id="{21E66674-2279-4BD2-9E34-AA50CF262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GB" dirty="0"/>
              <a:t>EHJ-CR-D-19-00139 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1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39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 38 year old female with a background of Marfan’s syndrome and dilation of the ascending aorta underwent elective valve sparing aortic root replacement (David procedure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10 days post operatively the patient called an ambulance from home after experiencing acute chest pain and shortness of breath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On arrival to hospital, the patient was in cardiogenic shock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1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4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5166194" y="1063625"/>
            <a:ext cx="3159099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Electrocardiogram (ECG) showed inferior-posterior ST segment elev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 patient was taken directly to the cardiac </a:t>
            </a:r>
            <a:r>
              <a:rPr lang="en-GB" b="0" dirty="0" err="1"/>
              <a:t>catherisation</a:t>
            </a:r>
            <a:r>
              <a:rPr lang="en-GB" b="0" dirty="0"/>
              <a:t> lab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  <p:pic>
        <p:nvPicPr>
          <p:cNvPr id="7" name="Picture 6" descr="A close up of a tennis court&#10;&#10;Description automatically generated">
            <a:extLst>
              <a:ext uri="{FF2B5EF4-FFF2-40B4-BE49-F238E27FC236}">
                <a16:creationId xmlns:a16="http://schemas.microsoft.com/office/drawing/2014/main" id="{9ADFFA06-31C8-459C-911E-99789D33349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063625"/>
            <a:ext cx="3989233" cy="27246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1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1" y="1199176"/>
            <a:ext cx="3759887" cy="3604822"/>
          </a:xfrm>
        </p:spPr>
        <p:txBody>
          <a:bodyPr>
            <a:normAutofit fontScale="77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Emergency coronary angiography showed extrinsic compression of the neo-ostium with resultant thrombosis of the right coronary artery (RCA)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e red arrow shows area of compression and thrombus.  This corresponds to intravascular ultrasound (IVUS) image showing thrombus and reduced luminal area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ere was urgent multidisciplinary discussion with cardiothoracic surgeons, cardiologists and cardiac anaesthetists about best reperfusion strateg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PCI performed with good angiographic results and prompt ST segment resolution</a:t>
            </a:r>
            <a:endParaRPr lang="en-GB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35349C3-87F4-4C1B-A0AA-7D9D384B920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23482"/>
          <a:stretch/>
        </p:blipFill>
        <p:spPr bwMode="auto">
          <a:xfrm>
            <a:off x="4867503" y="1711820"/>
            <a:ext cx="3985379" cy="2084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2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 53 year old man with known bicuspid aortic valve was admitted to hospital with decompensated heart failur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Updated echocardiography showed development of severe aortic regurgitation in the setting of severely dilated aortic root and moderate left ventricular systolic dysfunc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Once medications were optimised and patient stabilised, he proceeded to have an aortic valve repair with aortic root replacemen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When mobilising on the ward four days post operatively the patient experienced exertional chest pain</a:t>
            </a:r>
          </a:p>
        </p:txBody>
      </p:sp>
    </p:spTree>
    <p:extLst>
      <p:ext uri="{BB962C8B-B14F-4D97-AF65-F5344CB8AC3E}">
        <p14:creationId xmlns:p14="http://schemas.microsoft.com/office/powerpoint/2010/main" val="1004116006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2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3520330" y="1193572"/>
            <a:ext cx="4794330" cy="1635891"/>
          </a:xfrm>
        </p:spPr>
        <p:txBody>
          <a:bodyPr>
            <a:normAutofit fontScale="77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ECG showed atrial fibrillation with right bundle branch block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Peak high sensitivity troponin T was elevated at 489ng/ml (less than 14ng/ml is a negative result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Computed tomography coronary angiography (CTCA) was  suggestive of distortion of proximal right coronary artery, indicated with the blue arrow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C82C2D4-63C1-4A18-8604-B5CB556DFD3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r="63913"/>
          <a:stretch/>
        </p:blipFill>
        <p:spPr bwMode="auto">
          <a:xfrm>
            <a:off x="971550" y="1193574"/>
            <a:ext cx="2260748" cy="331353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3B057FC-91BC-494D-8FBA-862A9AA8A50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32347" t="29401" r="16930" b="29849"/>
          <a:stretch/>
        </p:blipFill>
        <p:spPr bwMode="auto">
          <a:xfrm>
            <a:off x="4233936" y="2829463"/>
            <a:ext cx="3355536" cy="168483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602364463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2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19-00139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199176"/>
            <a:ext cx="4259619" cy="3309323"/>
          </a:xfrm>
        </p:spPr>
        <p:txBody>
          <a:bodyPr>
            <a:normAutofit fontScale="92500"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e decision was made to proceed to invasive coronary angiography which showed ostial right coronary artery stenosis, indicated with the blue arrow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e case was discussed urgently with the multidisciplinary team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Following discussion, the patient was treated with PCI of ostial RCA with good angiographic resul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e green arrow shows the treated area after PCI</a:t>
            </a:r>
            <a:endParaRPr lang="en-GB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7D4F1A8-1BF0-4C60-845F-81873FE92C12}"/>
              </a:ext>
            </a:extLst>
          </p:cNvPr>
          <p:cNvPicPr/>
          <p:nvPr/>
        </p:nvPicPr>
        <p:blipFill rotWithShape="1">
          <a:blip r:embed="rId2" cstate="print"/>
          <a:srcRect l="36458"/>
          <a:stretch/>
        </p:blipFill>
        <p:spPr bwMode="auto">
          <a:xfrm>
            <a:off x="5231219" y="1199176"/>
            <a:ext cx="3641932" cy="3031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8839330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39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300130" cy="316800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Coronary obstruction is an uncommon, but potentially life threatening, complication of operations involving coronary button implant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re are multiple possible causes including:</a:t>
            </a:r>
          </a:p>
          <a:p>
            <a:pPr marL="702900" lvl="3" indent="-342900"/>
            <a:r>
              <a:rPr lang="en-GB" b="0" dirty="0"/>
              <a:t>external compression by organisation of haematoma</a:t>
            </a:r>
          </a:p>
          <a:p>
            <a:pPr marL="702900" lvl="3" indent="-342900"/>
            <a:r>
              <a:rPr lang="en-GB" dirty="0"/>
              <a:t>d</a:t>
            </a:r>
            <a:r>
              <a:rPr lang="en-GB" b="0" dirty="0"/>
              <a:t>amage during instrumentation of the coronary button (2)</a:t>
            </a:r>
          </a:p>
          <a:p>
            <a:pPr marL="702900" lvl="3" indent="-342900"/>
            <a:r>
              <a:rPr lang="en-GB" b="0" dirty="0"/>
              <a:t>tension through the coronary ostium (3)</a:t>
            </a:r>
          </a:p>
          <a:p>
            <a:pPr marL="702900" lvl="3" indent="-342900"/>
            <a:r>
              <a:rPr lang="en-GB" dirty="0"/>
              <a:t>external pressure from or r</a:t>
            </a:r>
            <a:r>
              <a:rPr lang="en-GB" b="0" dirty="0"/>
              <a:t>eaction to surgical glue (4) (5)</a:t>
            </a:r>
          </a:p>
          <a:p>
            <a:pPr marL="702900" lvl="3" indent="-342900"/>
            <a:r>
              <a:rPr lang="en-GB" dirty="0"/>
              <a:t>oedema at the anastomosis site (6)</a:t>
            </a:r>
            <a:endParaRPr lang="en-GB" b="0" dirty="0"/>
          </a:p>
          <a:p>
            <a:pPr marL="702900" lvl="3" indent="-342900"/>
            <a:r>
              <a:rPr lang="en-GB" b="0" dirty="0"/>
              <a:t>unrecognised preoperative coronary disease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9</TotalTime>
  <Words>978</Words>
  <Application>Microsoft Office PowerPoint</Application>
  <PresentationFormat>On-screen Show (16:9)</PresentationFormat>
  <Paragraphs>81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Post-operative myocardial infarction following aortic root surgery with coronary reimplantation: a case series treated with PCI </vt:lpstr>
      <vt:lpstr>Introduction</vt:lpstr>
      <vt:lpstr>Case Presentation 1 History and Examination Findings</vt:lpstr>
      <vt:lpstr>Case Presentation 1 Investigations</vt:lpstr>
      <vt:lpstr>Case Presentation 1 Management</vt:lpstr>
      <vt:lpstr>Case Presentation 2 History and Examination Findings</vt:lpstr>
      <vt:lpstr>Case Presentation 2 Investigations</vt:lpstr>
      <vt:lpstr>Case Presentation 2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Carly Adamson</cp:lastModifiedBy>
  <cp:revision>68</cp:revision>
  <dcterms:created xsi:type="dcterms:W3CDTF">2017-10-02T09:19:02Z</dcterms:created>
  <dcterms:modified xsi:type="dcterms:W3CDTF">2019-09-08T11:49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